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249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3730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8398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3573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486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026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883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617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024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601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273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81013-9BF9-4A48-AEF0-AB48259EA4A7}" type="datetimeFigureOut">
              <a:rPr lang="zh-CN" altLang="en-US" smtClean="0"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B9364-94A5-463C-A698-10C7322F1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1922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0050445"/>
              </p:ext>
            </p:extLst>
          </p:nvPr>
        </p:nvGraphicFramePr>
        <p:xfrm>
          <a:off x="1334679" y="48115"/>
          <a:ext cx="9522643" cy="67276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88608">
                  <a:extLst>
                    <a:ext uri="{9D8B030D-6E8A-4147-A177-3AD203B41FA5}">
                      <a16:colId xmlns:a16="http://schemas.microsoft.com/office/drawing/2014/main" xmlns="" val="305179475"/>
                    </a:ext>
                  </a:extLst>
                </a:gridCol>
                <a:gridCol w="704523">
                  <a:extLst>
                    <a:ext uri="{9D8B030D-6E8A-4147-A177-3AD203B41FA5}">
                      <a16:colId xmlns:a16="http://schemas.microsoft.com/office/drawing/2014/main" xmlns="" val="2318551821"/>
                    </a:ext>
                  </a:extLst>
                </a:gridCol>
                <a:gridCol w="1894787">
                  <a:extLst>
                    <a:ext uri="{9D8B030D-6E8A-4147-A177-3AD203B41FA5}">
                      <a16:colId xmlns:a16="http://schemas.microsoft.com/office/drawing/2014/main" xmlns="" val="4015473058"/>
                    </a:ext>
                  </a:extLst>
                </a:gridCol>
                <a:gridCol w="1734532">
                  <a:extLst>
                    <a:ext uri="{9D8B030D-6E8A-4147-A177-3AD203B41FA5}">
                      <a16:colId xmlns:a16="http://schemas.microsoft.com/office/drawing/2014/main" xmlns="" val="2900444274"/>
                    </a:ext>
                  </a:extLst>
                </a:gridCol>
                <a:gridCol w="1170320">
                  <a:extLst>
                    <a:ext uri="{9D8B030D-6E8A-4147-A177-3AD203B41FA5}">
                      <a16:colId xmlns:a16="http://schemas.microsoft.com/office/drawing/2014/main" xmlns="" val="971847539"/>
                    </a:ext>
                  </a:extLst>
                </a:gridCol>
                <a:gridCol w="1154576">
                  <a:extLst>
                    <a:ext uri="{9D8B030D-6E8A-4147-A177-3AD203B41FA5}">
                      <a16:colId xmlns:a16="http://schemas.microsoft.com/office/drawing/2014/main" xmlns="" val="4076207354"/>
                    </a:ext>
                  </a:extLst>
                </a:gridCol>
                <a:gridCol w="765079">
                  <a:extLst>
                    <a:ext uri="{9D8B030D-6E8A-4147-A177-3AD203B41FA5}">
                      <a16:colId xmlns:a16="http://schemas.microsoft.com/office/drawing/2014/main" xmlns="" val="3287219941"/>
                    </a:ext>
                  </a:extLst>
                </a:gridCol>
                <a:gridCol w="1210218">
                  <a:extLst>
                    <a:ext uri="{9D8B030D-6E8A-4147-A177-3AD203B41FA5}">
                      <a16:colId xmlns:a16="http://schemas.microsoft.com/office/drawing/2014/main" xmlns="" val="1117735576"/>
                    </a:ext>
                  </a:extLst>
                </a:gridCol>
              </a:tblGrid>
              <a:tr h="375519">
                <a:tc gridSpan="8">
                  <a:txBody>
                    <a:bodyPr/>
                    <a:lstStyle/>
                    <a:p>
                      <a:pPr algn="l" rtl="0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1. The clinical trial data of CD47/</a:t>
                      </a:r>
                      <a:r>
                        <a:rPr lang="en-US" sz="14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Pɑ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1052680"/>
                  </a:ext>
                </a:extLst>
              </a:tr>
              <a:tr h="20518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g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red disease 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Strategy 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 date 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nsor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 number 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51877871"/>
                  </a:ext>
                </a:extLst>
              </a:tr>
              <a:tr h="28318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O-176 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bruary, 2019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ch Oncology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3834948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649235104"/>
                  </a:ext>
                </a:extLst>
              </a:tr>
              <a:tr h="28318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BI187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anced Malignancies 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nuary, 2019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novent Biologics (Suzhou) Co. Ltd.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CT03763149</a:t>
                      </a:r>
                      <a:endParaRPr lang="en-US" sz="95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363448850"/>
                  </a:ext>
                </a:extLst>
              </a:tr>
              <a:tr h="28564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BI188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anced Malignancies 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or combination with Rituximab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ember, 2018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novent</a:t>
                      </a:r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iologics (Suzhou) Co. Ltd.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 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3717103</a:t>
                      </a:r>
                      <a:endParaRPr lang="en-US" sz="9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423361290"/>
                  </a:ext>
                </a:extLst>
              </a:tr>
              <a:tr h="36302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F231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anced Solid Cancer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logic Cancer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ch, 2018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Oncology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3512340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494649720"/>
                  </a:ext>
                </a:extLst>
              </a:tr>
              <a:tr h="19218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5F9-G4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gust, 2014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ty Seven, Inc.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216409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412821733"/>
                  </a:ext>
                </a:extLst>
              </a:tr>
              <a:tr h="42223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5F9-G4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ute Myeloid Leukemia Myelodysplastic Syndrom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ember, 2015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ty Seven, </a:t>
                      </a:r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678338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396803044"/>
                  </a:ext>
                </a:extLst>
              </a:tr>
              <a:tr h="62216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5F9-G4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ma, Non Hodgkin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ma, Large B-Cell, Diffus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nt Lymphoma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combined </a:t>
                      </a:r>
                      <a:r>
                        <a:rPr lang="en-US" altLang="zh-CN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</a:t>
                      </a: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h Rituximab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ember, 201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ty Seven, Inc.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Leukemia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 Lymphoma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ety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/2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953509 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983497468"/>
                  </a:ext>
                </a:extLst>
              </a:tr>
              <a:tr h="4064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5F9-G4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rectal Neoplasm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</a:t>
                      </a:r>
                      <a:r>
                        <a:rPr lang="en-US" altLang="zh-CN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with </a:t>
                      </a: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tuximab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ember, 201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ty Seven, Inc.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/2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953782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913621458"/>
                  </a:ext>
                </a:extLst>
              </a:tr>
              <a:tr h="41052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5F9-G4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ute Myeloid Leukemia Myelodysplastic Syndrome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or combined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</a:t>
                      </a:r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acitidin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tember, 201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ty Seven, Inc.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3248479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514269255"/>
                  </a:ext>
                </a:extLst>
              </a:tr>
              <a:tr h="4179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TI-621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logic Malignancie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combined with Rituximab or Nivolumab 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nuary, 201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llium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eutic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.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663518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95248673"/>
                  </a:ext>
                </a:extLst>
              </a:tr>
              <a:tr h="59054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TI-62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s/breast/Melanoma </a:t>
                      </a:r>
                      <a:r>
                        <a:rPr lang="en-US" altLang="zh-CN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cinoma</a:t>
                      </a:r>
                      <a:endParaRPr lang="en-US" altLang="zh-CN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 or combined with PD-1/PD-L1 inhibitor pegylated interferon-#2a or T-</a:t>
                      </a:r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c</a:t>
                      </a: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r radiation therapy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tember, 201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llium </a:t>
                      </a:r>
                      <a:r>
                        <a:rPr lang="en-US" altLang="zh-CN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eutics</a:t>
                      </a:r>
                      <a:endParaRPr lang="en-US" altLang="zh-CN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.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890368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68144638"/>
                  </a:ext>
                </a:extLst>
              </a:tr>
              <a:tr h="4853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C-90002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logic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plasm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or combined with Rituximab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ch, 2015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gene Corporation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36719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3790480146"/>
                  </a:ext>
                </a:extLst>
              </a:tr>
              <a:tr h="36302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C-90002 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kemia, Myeloid, Acut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dysplastic Syndrome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 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ch, 2016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gene Corporation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641002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2836933405"/>
                  </a:ext>
                </a:extLst>
              </a:tr>
              <a:tr h="6915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X148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7</a:t>
                      </a:r>
                      <a:endParaRPr lang="en-US" sz="9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Cancer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r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anced Cancer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Hodgkin Lymphoma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ngle agent combination with Pembrolizumab or  Trastuzumab or </a:t>
                      </a:r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ximab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bruary, 2017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o</a:t>
                      </a: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herapeutics,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.</a:t>
                      </a:r>
                      <a:r>
                        <a:rPr lang="en-US" sz="9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zh-CN" alt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1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3013218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xmlns="" val="1000907864"/>
                  </a:ext>
                </a:extLst>
              </a:tr>
              <a:tr h="28564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Pɑ</a:t>
                      </a:r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b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Pɑ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ocellular Carcinoma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ection of human samples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gust, 2016 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tes University Hospital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estigation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T02868255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432" marR="3432" marT="3432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981649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30088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2910623"/>
              </p:ext>
            </p:extLst>
          </p:nvPr>
        </p:nvGraphicFramePr>
        <p:xfrm>
          <a:off x="1852654" y="532738"/>
          <a:ext cx="7975158" cy="5932920"/>
        </p:xfrm>
        <a:graphic>
          <a:graphicData uri="http://schemas.openxmlformats.org/drawingml/2006/table">
            <a:tbl>
              <a:tblPr/>
              <a:tblGrid>
                <a:gridCol w="1566407">
                  <a:extLst>
                    <a:ext uri="{9D8B030D-6E8A-4147-A177-3AD203B41FA5}">
                      <a16:colId xmlns:a16="http://schemas.microsoft.com/office/drawing/2014/main" xmlns="" val="2953685395"/>
                    </a:ext>
                  </a:extLst>
                </a:gridCol>
                <a:gridCol w="2162755">
                  <a:extLst>
                    <a:ext uri="{9D8B030D-6E8A-4147-A177-3AD203B41FA5}">
                      <a16:colId xmlns:a16="http://schemas.microsoft.com/office/drawing/2014/main" xmlns="" val="4112742877"/>
                    </a:ext>
                  </a:extLst>
                </a:gridCol>
                <a:gridCol w="993913">
                  <a:extLst>
                    <a:ext uri="{9D8B030D-6E8A-4147-A177-3AD203B41FA5}">
                      <a16:colId xmlns:a16="http://schemas.microsoft.com/office/drawing/2014/main" xmlns="" val="640180990"/>
                    </a:ext>
                  </a:extLst>
                </a:gridCol>
                <a:gridCol w="1948069">
                  <a:extLst>
                    <a:ext uri="{9D8B030D-6E8A-4147-A177-3AD203B41FA5}">
                      <a16:colId xmlns:a16="http://schemas.microsoft.com/office/drawing/2014/main" xmlns="" val="2036643114"/>
                    </a:ext>
                  </a:extLst>
                </a:gridCol>
                <a:gridCol w="1304014">
                  <a:extLst>
                    <a:ext uri="{9D8B030D-6E8A-4147-A177-3AD203B41FA5}">
                      <a16:colId xmlns:a16="http://schemas.microsoft.com/office/drawing/2014/main" xmlns="" val="2474164075"/>
                    </a:ext>
                  </a:extLst>
                </a:gridCol>
              </a:tblGrid>
              <a:tr h="395528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ble S1. The antagonists for blocking human CD47/</a:t>
                      </a:r>
                      <a:r>
                        <a:rPr lang="en-US" altLang="zh-CN" sz="15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IRPɑ</a:t>
                      </a:r>
                      <a:r>
                        <a:rPr lang="en-US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axis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92795835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arget 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gent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nds to FCR 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xample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linical trial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7337118"/>
                  </a:ext>
                </a:extLst>
              </a:tr>
              <a:tr h="395528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7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-CD47 antibody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RF231/Hu5F9-G4/CC90002/B6H12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ase 1/2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83374930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MS4-G4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39821336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WT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IRPɑ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FC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I-621/SIRPɑD1–Fc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ase 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89294420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gineered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IRPɑ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FC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V1-hIgG4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49722371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gineered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IRPɑ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inactive FC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LX148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ase 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03518187"/>
                  </a:ext>
                </a:extLst>
              </a:tr>
              <a:tr h="395528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IRPɑ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gineered CD47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elcro-CD47 N3612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49707297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-SIRP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α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body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KWAR23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89750289"/>
                  </a:ext>
                </a:extLst>
              </a:tr>
              <a:tr h="39552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ffi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DEM 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eclinical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56031015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7/CD19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specific antibody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I-170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eclinical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18162937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7/Mesothelin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I-180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eclinical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83035948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7/CD20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20-CD47 SL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98958819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47/PD-L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specific fusion protein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AB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17601461"/>
                  </a:ext>
                </a:extLst>
              </a:tr>
              <a:tr h="3955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CD47/VEGF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EGFR1D2-SIRP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1</a:t>
                      </a: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1200" b="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883" marR="7883" marT="78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994317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1671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52</Words>
  <Application>Microsoft Office PowerPoint</Application>
  <PresentationFormat>宽屏</PresentationFormat>
  <Paragraphs>20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R</cp:lastModifiedBy>
  <cp:revision>2</cp:revision>
  <dcterms:created xsi:type="dcterms:W3CDTF">2019-05-27T13:43:26Z</dcterms:created>
  <dcterms:modified xsi:type="dcterms:W3CDTF">2019-05-27T13:52:41Z</dcterms:modified>
</cp:coreProperties>
</file>